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5/04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1B5B82-9918-68E5-AB7D-C059B99DF8E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A160475-D31B-EA7D-AB4B-341AE271F02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0930C54-9552-6B87-683C-D2083F8075C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CB382C-E3F1-1050-BD2B-78A982DCF6B3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980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5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445224"/>
            <a:ext cx="686017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/>
              <a:t>Mikael Rydén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2026) Diabetologia DOI 10.1007/s00125-026-06735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260648"/>
            <a:ext cx="8640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Structural and molecular determinants of the adiposity set poin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74DB85A-E043-6383-EC7C-49ED15E891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2343" y="980728"/>
            <a:ext cx="7019315" cy="4681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3CFFF98-F130-C560-5245-71E52910DF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0FA1B03F-0011-8978-53F0-A3ED41D9D40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A5A58AC-9DB3-5296-F019-374334E6EBB1}"/>
              </a:ext>
            </a:extLst>
          </p:cNvPr>
          <p:cNvSpPr txBox="1"/>
          <p:nvPr/>
        </p:nvSpPr>
        <p:spPr>
          <a:xfrm>
            <a:off x="395536" y="260648"/>
            <a:ext cx="8352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Spatial organisation of adipocyte states and depot-specific immune modulation in human WA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7F39CC-2EBB-BFAF-7F1E-6616A6FC50BD}"/>
              </a:ext>
            </a:extLst>
          </p:cNvPr>
          <p:cNvSpPr txBox="1"/>
          <p:nvPr/>
        </p:nvSpPr>
        <p:spPr>
          <a:xfrm>
            <a:off x="107504" y="5448706"/>
            <a:ext cx="657214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/>
              <a:t>Mikael Rydén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2026) Diabetologia DOI 10.1007/s00125-026-06735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3CD33DE-F6B1-F395-94DA-9B74FC9F5E4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462"/>
          <a:stretch>
            <a:fillRect/>
          </a:stretch>
        </p:blipFill>
        <p:spPr>
          <a:xfrm>
            <a:off x="1835696" y="892115"/>
            <a:ext cx="4104456" cy="487991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A9AE73D-44F6-1712-BDB9-8A8FF30B9C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9566" y="3356992"/>
            <a:ext cx="2638897" cy="1854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1594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9</cp:revision>
  <dcterms:created xsi:type="dcterms:W3CDTF">2016-06-15T12:53:43Z</dcterms:created>
  <dcterms:modified xsi:type="dcterms:W3CDTF">2026-04-15T15:43:03Z</dcterms:modified>
</cp:coreProperties>
</file>